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60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71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4228826622988063E-2"/>
          <c:y val="3.1144573975130981E-2"/>
          <c:w val="0.9115423467540239"/>
          <c:h val="0.69914456902093169"/>
        </c:manualLayout>
      </c:layout>
      <c:barChart>
        <c:barDir val="col"/>
        <c:grouping val="clustered"/>
        <c:varyColors val="0"/>
        <c:ser>
          <c:idx val="3"/>
          <c:order val="3"/>
          <c:tx>
            <c:strRef>
              <c:f>Sheet1!$A$5</c:f>
              <c:strCache>
                <c:ptCount val="1"/>
                <c:pt idx="0">
                  <c:v>RBC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B$1:$AC$1</c:f>
              <c:strCache>
                <c:ptCount val="28"/>
                <c:pt idx="0">
                  <c:v>POD1</c:v>
                </c:pt>
                <c:pt idx="1">
                  <c:v>POD2</c:v>
                </c:pt>
                <c:pt idx="2">
                  <c:v>POD3</c:v>
                </c:pt>
                <c:pt idx="3">
                  <c:v>POD4</c:v>
                </c:pt>
                <c:pt idx="4">
                  <c:v>POD5</c:v>
                </c:pt>
                <c:pt idx="5">
                  <c:v>POD6</c:v>
                </c:pt>
                <c:pt idx="6">
                  <c:v>POD7</c:v>
                </c:pt>
                <c:pt idx="7">
                  <c:v>POD8</c:v>
                </c:pt>
                <c:pt idx="8">
                  <c:v>POD9</c:v>
                </c:pt>
                <c:pt idx="9">
                  <c:v>POD10</c:v>
                </c:pt>
                <c:pt idx="10">
                  <c:v>POD11</c:v>
                </c:pt>
                <c:pt idx="11">
                  <c:v>POD12</c:v>
                </c:pt>
                <c:pt idx="12">
                  <c:v>POD13</c:v>
                </c:pt>
                <c:pt idx="13">
                  <c:v>POD14</c:v>
                </c:pt>
                <c:pt idx="14">
                  <c:v>POD15</c:v>
                </c:pt>
                <c:pt idx="15">
                  <c:v>POD16</c:v>
                </c:pt>
                <c:pt idx="16">
                  <c:v>POD17</c:v>
                </c:pt>
                <c:pt idx="17">
                  <c:v>POD18</c:v>
                </c:pt>
                <c:pt idx="18">
                  <c:v>POD19</c:v>
                </c:pt>
                <c:pt idx="19">
                  <c:v>POD20</c:v>
                </c:pt>
                <c:pt idx="20">
                  <c:v>POD21</c:v>
                </c:pt>
                <c:pt idx="21">
                  <c:v>POD22</c:v>
                </c:pt>
                <c:pt idx="22">
                  <c:v>POD23</c:v>
                </c:pt>
                <c:pt idx="23">
                  <c:v>POD24</c:v>
                </c:pt>
                <c:pt idx="24">
                  <c:v>POD25</c:v>
                </c:pt>
                <c:pt idx="25">
                  <c:v>POD26</c:v>
                </c:pt>
                <c:pt idx="26">
                  <c:v>POD27</c:v>
                </c:pt>
                <c:pt idx="27">
                  <c:v>POD28</c:v>
                </c:pt>
              </c:strCache>
            </c:strRef>
          </c:cat>
          <c:val>
            <c:numRef>
              <c:f>Sheet1!$B$5:$AC$5</c:f>
              <c:numCache>
                <c:formatCode>General</c:formatCode>
                <c:ptCount val="28"/>
                <c:pt idx="9">
                  <c:v>4</c:v>
                </c:pt>
                <c:pt idx="10">
                  <c:v>4</c:v>
                </c:pt>
                <c:pt idx="11">
                  <c:v>6</c:v>
                </c:pt>
                <c:pt idx="12">
                  <c:v>2</c:v>
                </c:pt>
                <c:pt idx="26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0E-4039-A7F4-A7DED1B19AF6}"/>
            </c:ext>
          </c:extLst>
        </c:ser>
        <c:ser>
          <c:idx val="4"/>
          <c:order val="4"/>
          <c:tx>
            <c:strRef>
              <c:f>Sheet1!$A$6</c:f>
              <c:strCache>
                <c:ptCount val="1"/>
                <c:pt idx="0">
                  <c:v>FFP</c:v>
                </c:pt>
              </c:strCache>
            </c:strRef>
          </c:tx>
          <c:spPr>
            <a:pattFill prst="pct40">
              <a:fgClr>
                <a:schemeClr val="tx1">
                  <a:lumMod val="50000"/>
                  <a:lumOff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B$1:$AC$1</c:f>
              <c:strCache>
                <c:ptCount val="28"/>
                <c:pt idx="0">
                  <c:v>POD1</c:v>
                </c:pt>
                <c:pt idx="1">
                  <c:v>POD2</c:v>
                </c:pt>
                <c:pt idx="2">
                  <c:v>POD3</c:v>
                </c:pt>
                <c:pt idx="3">
                  <c:v>POD4</c:v>
                </c:pt>
                <c:pt idx="4">
                  <c:v>POD5</c:v>
                </c:pt>
                <c:pt idx="5">
                  <c:v>POD6</c:v>
                </c:pt>
                <c:pt idx="6">
                  <c:v>POD7</c:v>
                </c:pt>
                <c:pt idx="7">
                  <c:v>POD8</c:v>
                </c:pt>
                <c:pt idx="8">
                  <c:v>POD9</c:v>
                </c:pt>
                <c:pt idx="9">
                  <c:v>POD10</c:v>
                </c:pt>
                <c:pt idx="10">
                  <c:v>POD11</c:v>
                </c:pt>
                <c:pt idx="11">
                  <c:v>POD12</c:v>
                </c:pt>
                <c:pt idx="12">
                  <c:v>POD13</c:v>
                </c:pt>
                <c:pt idx="13">
                  <c:v>POD14</c:v>
                </c:pt>
                <c:pt idx="14">
                  <c:v>POD15</c:v>
                </c:pt>
                <c:pt idx="15">
                  <c:v>POD16</c:v>
                </c:pt>
                <c:pt idx="16">
                  <c:v>POD17</c:v>
                </c:pt>
                <c:pt idx="17">
                  <c:v>POD18</c:v>
                </c:pt>
                <c:pt idx="18">
                  <c:v>POD19</c:v>
                </c:pt>
                <c:pt idx="19">
                  <c:v>POD20</c:v>
                </c:pt>
                <c:pt idx="20">
                  <c:v>POD21</c:v>
                </c:pt>
                <c:pt idx="21">
                  <c:v>POD22</c:v>
                </c:pt>
                <c:pt idx="22">
                  <c:v>POD23</c:v>
                </c:pt>
                <c:pt idx="23">
                  <c:v>POD24</c:v>
                </c:pt>
                <c:pt idx="24">
                  <c:v>POD25</c:v>
                </c:pt>
                <c:pt idx="25">
                  <c:v>POD26</c:v>
                </c:pt>
                <c:pt idx="26">
                  <c:v>POD27</c:v>
                </c:pt>
                <c:pt idx="27">
                  <c:v>POD28</c:v>
                </c:pt>
              </c:strCache>
            </c:strRef>
          </c:cat>
          <c:val>
            <c:numRef>
              <c:f>Sheet1!$B$6:$AC$6</c:f>
              <c:numCache>
                <c:formatCode>General</c:formatCode>
                <c:ptCount val="28"/>
                <c:pt idx="10">
                  <c:v>5</c:v>
                </c:pt>
                <c:pt idx="11">
                  <c:v>4</c:v>
                </c:pt>
                <c:pt idx="1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90E-4039-A7F4-A7DED1B19AF6}"/>
            </c:ext>
          </c:extLst>
        </c:ser>
        <c:ser>
          <c:idx val="5"/>
          <c:order val="5"/>
          <c:tx>
            <c:strRef>
              <c:f>Sheet1!$A$7</c:f>
              <c:strCache>
                <c:ptCount val="1"/>
                <c:pt idx="0">
                  <c:v>PC</c:v>
                </c:pt>
              </c:strCache>
            </c:strRef>
          </c:tx>
          <c:spPr>
            <a:pattFill prst="ltUpDiag">
              <a:fgClr>
                <a:schemeClr val="tx1">
                  <a:lumMod val="50000"/>
                  <a:lumOff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B$1:$AC$1</c:f>
              <c:strCache>
                <c:ptCount val="28"/>
                <c:pt idx="0">
                  <c:v>POD1</c:v>
                </c:pt>
                <c:pt idx="1">
                  <c:v>POD2</c:v>
                </c:pt>
                <c:pt idx="2">
                  <c:v>POD3</c:v>
                </c:pt>
                <c:pt idx="3">
                  <c:v>POD4</c:v>
                </c:pt>
                <c:pt idx="4">
                  <c:v>POD5</c:v>
                </c:pt>
                <c:pt idx="5">
                  <c:v>POD6</c:v>
                </c:pt>
                <c:pt idx="6">
                  <c:v>POD7</c:v>
                </c:pt>
                <c:pt idx="7">
                  <c:v>POD8</c:v>
                </c:pt>
                <c:pt idx="8">
                  <c:v>POD9</c:v>
                </c:pt>
                <c:pt idx="9">
                  <c:v>POD10</c:v>
                </c:pt>
                <c:pt idx="10">
                  <c:v>POD11</c:v>
                </c:pt>
                <c:pt idx="11">
                  <c:v>POD12</c:v>
                </c:pt>
                <c:pt idx="12">
                  <c:v>POD13</c:v>
                </c:pt>
                <c:pt idx="13">
                  <c:v>POD14</c:v>
                </c:pt>
                <c:pt idx="14">
                  <c:v>POD15</c:v>
                </c:pt>
                <c:pt idx="15">
                  <c:v>POD16</c:v>
                </c:pt>
                <c:pt idx="16">
                  <c:v>POD17</c:v>
                </c:pt>
                <c:pt idx="17">
                  <c:v>POD18</c:v>
                </c:pt>
                <c:pt idx="18">
                  <c:v>POD19</c:v>
                </c:pt>
                <c:pt idx="19">
                  <c:v>POD20</c:v>
                </c:pt>
                <c:pt idx="20">
                  <c:v>POD21</c:v>
                </c:pt>
                <c:pt idx="21">
                  <c:v>POD22</c:v>
                </c:pt>
                <c:pt idx="22">
                  <c:v>POD23</c:v>
                </c:pt>
                <c:pt idx="23">
                  <c:v>POD24</c:v>
                </c:pt>
                <c:pt idx="24">
                  <c:v>POD25</c:v>
                </c:pt>
                <c:pt idx="25">
                  <c:v>POD26</c:v>
                </c:pt>
                <c:pt idx="26">
                  <c:v>POD27</c:v>
                </c:pt>
                <c:pt idx="27">
                  <c:v>POD28</c:v>
                </c:pt>
              </c:strCache>
            </c:strRef>
          </c:cat>
          <c:val>
            <c:numRef>
              <c:f>Sheet1!$B$7:$AC$7</c:f>
              <c:numCache>
                <c:formatCode>General</c:formatCode>
                <c:ptCount val="28"/>
                <c:pt idx="10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90E-4039-A7F4-A7DED1B19A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03548392"/>
        <c:axId val="703549832"/>
      </c:barChart>
      <c:lineChart>
        <c:grouping val="standar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Hb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B$1:$AC$1</c:f>
              <c:strCache>
                <c:ptCount val="28"/>
                <c:pt idx="0">
                  <c:v>POD1</c:v>
                </c:pt>
                <c:pt idx="1">
                  <c:v>POD2</c:v>
                </c:pt>
                <c:pt idx="2">
                  <c:v>POD3</c:v>
                </c:pt>
                <c:pt idx="3">
                  <c:v>POD4</c:v>
                </c:pt>
                <c:pt idx="4">
                  <c:v>POD5</c:v>
                </c:pt>
                <c:pt idx="5">
                  <c:v>POD6</c:v>
                </c:pt>
                <c:pt idx="6">
                  <c:v>POD7</c:v>
                </c:pt>
                <c:pt idx="7">
                  <c:v>POD8</c:v>
                </c:pt>
                <c:pt idx="8">
                  <c:v>POD9</c:v>
                </c:pt>
                <c:pt idx="9">
                  <c:v>POD10</c:v>
                </c:pt>
                <c:pt idx="10">
                  <c:v>POD11</c:v>
                </c:pt>
                <c:pt idx="11">
                  <c:v>POD12</c:v>
                </c:pt>
                <c:pt idx="12">
                  <c:v>POD13</c:v>
                </c:pt>
                <c:pt idx="13">
                  <c:v>POD14</c:v>
                </c:pt>
                <c:pt idx="14">
                  <c:v>POD15</c:v>
                </c:pt>
                <c:pt idx="15">
                  <c:v>POD16</c:v>
                </c:pt>
                <c:pt idx="16">
                  <c:v>POD17</c:v>
                </c:pt>
                <c:pt idx="17">
                  <c:v>POD18</c:v>
                </c:pt>
                <c:pt idx="18">
                  <c:v>POD19</c:v>
                </c:pt>
                <c:pt idx="19">
                  <c:v>POD20</c:v>
                </c:pt>
                <c:pt idx="20">
                  <c:v>POD21</c:v>
                </c:pt>
                <c:pt idx="21">
                  <c:v>POD22</c:v>
                </c:pt>
                <c:pt idx="22">
                  <c:v>POD23</c:v>
                </c:pt>
                <c:pt idx="23">
                  <c:v>POD24</c:v>
                </c:pt>
                <c:pt idx="24">
                  <c:v>POD25</c:v>
                </c:pt>
                <c:pt idx="25">
                  <c:v>POD26</c:v>
                </c:pt>
                <c:pt idx="26">
                  <c:v>POD27</c:v>
                </c:pt>
                <c:pt idx="27">
                  <c:v>POD28</c:v>
                </c:pt>
              </c:strCache>
            </c:strRef>
          </c:cat>
          <c:val>
            <c:numRef>
              <c:f>Sheet1!$B$2:$AC$2</c:f>
              <c:numCache>
                <c:formatCode>General</c:formatCode>
                <c:ptCount val="28"/>
                <c:pt idx="0">
                  <c:v>10.1</c:v>
                </c:pt>
                <c:pt idx="1">
                  <c:v>10.5</c:v>
                </c:pt>
                <c:pt idx="2">
                  <c:v>9.6999999999999993</c:v>
                </c:pt>
                <c:pt idx="3">
                  <c:v>9.5</c:v>
                </c:pt>
                <c:pt idx="5">
                  <c:v>8.6999999999999993</c:v>
                </c:pt>
                <c:pt idx="7">
                  <c:v>9</c:v>
                </c:pt>
                <c:pt idx="9">
                  <c:v>8.1</c:v>
                </c:pt>
                <c:pt idx="10">
                  <c:v>6.2</c:v>
                </c:pt>
                <c:pt idx="11">
                  <c:v>7.8</c:v>
                </c:pt>
                <c:pt idx="12">
                  <c:v>8.6</c:v>
                </c:pt>
                <c:pt idx="13">
                  <c:v>9.1999999999999993</c:v>
                </c:pt>
                <c:pt idx="14">
                  <c:v>10.1</c:v>
                </c:pt>
                <c:pt idx="15">
                  <c:v>9.4</c:v>
                </c:pt>
                <c:pt idx="17">
                  <c:v>8.9</c:v>
                </c:pt>
                <c:pt idx="18">
                  <c:v>9</c:v>
                </c:pt>
                <c:pt idx="19">
                  <c:v>8.3000000000000007</c:v>
                </c:pt>
                <c:pt idx="20">
                  <c:v>7.4</c:v>
                </c:pt>
                <c:pt idx="21">
                  <c:v>8</c:v>
                </c:pt>
                <c:pt idx="22">
                  <c:v>8.5</c:v>
                </c:pt>
                <c:pt idx="23">
                  <c:v>7.3</c:v>
                </c:pt>
                <c:pt idx="25">
                  <c:v>6.3</c:v>
                </c:pt>
                <c:pt idx="26">
                  <c:v>6.3</c:v>
                </c:pt>
                <c:pt idx="27">
                  <c:v>7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90E-4039-A7F4-A7DED1B19AF6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PLT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B$1:$AC$1</c:f>
              <c:strCache>
                <c:ptCount val="28"/>
                <c:pt idx="0">
                  <c:v>POD1</c:v>
                </c:pt>
                <c:pt idx="1">
                  <c:v>POD2</c:v>
                </c:pt>
                <c:pt idx="2">
                  <c:v>POD3</c:v>
                </c:pt>
                <c:pt idx="3">
                  <c:v>POD4</c:v>
                </c:pt>
                <c:pt idx="4">
                  <c:v>POD5</c:v>
                </c:pt>
                <c:pt idx="5">
                  <c:v>POD6</c:v>
                </c:pt>
                <c:pt idx="6">
                  <c:v>POD7</c:v>
                </c:pt>
                <c:pt idx="7">
                  <c:v>POD8</c:v>
                </c:pt>
                <c:pt idx="8">
                  <c:v>POD9</c:v>
                </c:pt>
                <c:pt idx="9">
                  <c:v>POD10</c:v>
                </c:pt>
                <c:pt idx="10">
                  <c:v>POD11</c:v>
                </c:pt>
                <c:pt idx="11">
                  <c:v>POD12</c:v>
                </c:pt>
                <c:pt idx="12">
                  <c:v>POD13</c:v>
                </c:pt>
                <c:pt idx="13">
                  <c:v>POD14</c:v>
                </c:pt>
                <c:pt idx="14">
                  <c:v>POD15</c:v>
                </c:pt>
                <c:pt idx="15">
                  <c:v>POD16</c:v>
                </c:pt>
                <c:pt idx="16">
                  <c:v>POD17</c:v>
                </c:pt>
                <c:pt idx="17">
                  <c:v>POD18</c:v>
                </c:pt>
                <c:pt idx="18">
                  <c:v>POD19</c:v>
                </c:pt>
                <c:pt idx="19">
                  <c:v>POD20</c:v>
                </c:pt>
                <c:pt idx="20">
                  <c:v>POD21</c:v>
                </c:pt>
                <c:pt idx="21">
                  <c:v>POD22</c:v>
                </c:pt>
                <c:pt idx="22">
                  <c:v>POD23</c:v>
                </c:pt>
                <c:pt idx="23">
                  <c:v>POD24</c:v>
                </c:pt>
                <c:pt idx="24">
                  <c:v>POD25</c:v>
                </c:pt>
                <c:pt idx="25">
                  <c:v>POD26</c:v>
                </c:pt>
                <c:pt idx="26">
                  <c:v>POD27</c:v>
                </c:pt>
                <c:pt idx="27">
                  <c:v>POD28</c:v>
                </c:pt>
              </c:strCache>
            </c:strRef>
          </c:cat>
          <c:val>
            <c:numRef>
              <c:f>Sheet1!$B$3:$AC$3</c:f>
              <c:numCache>
                <c:formatCode>General</c:formatCode>
                <c:ptCount val="28"/>
                <c:pt idx="0">
                  <c:v>6.7</c:v>
                </c:pt>
                <c:pt idx="1">
                  <c:v>7.6</c:v>
                </c:pt>
                <c:pt idx="2">
                  <c:v>7.2</c:v>
                </c:pt>
                <c:pt idx="3">
                  <c:v>7.2</c:v>
                </c:pt>
                <c:pt idx="5">
                  <c:v>7.6</c:v>
                </c:pt>
                <c:pt idx="7">
                  <c:v>6.9</c:v>
                </c:pt>
                <c:pt idx="9">
                  <c:v>7.4</c:v>
                </c:pt>
                <c:pt idx="10">
                  <c:v>6.3</c:v>
                </c:pt>
                <c:pt idx="11">
                  <c:v>13.9</c:v>
                </c:pt>
                <c:pt idx="12">
                  <c:v>7.9</c:v>
                </c:pt>
                <c:pt idx="13">
                  <c:v>4.9000000000000004</c:v>
                </c:pt>
                <c:pt idx="14">
                  <c:v>3.7</c:v>
                </c:pt>
                <c:pt idx="15">
                  <c:v>3.7</c:v>
                </c:pt>
                <c:pt idx="17">
                  <c:v>4.5999999999999996</c:v>
                </c:pt>
                <c:pt idx="18">
                  <c:v>5.2</c:v>
                </c:pt>
                <c:pt idx="19">
                  <c:v>4.5999999999999996</c:v>
                </c:pt>
                <c:pt idx="20">
                  <c:v>4.5999999999999996</c:v>
                </c:pt>
                <c:pt idx="21">
                  <c:v>12.2</c:v>
                </c:pt>
                <c:pt idx="22">
                  <c:v>7.1</c:v>
                </c:pt>
                <c:pt idx="23">
                  <c:v>7.6</c:v>
                </c:pt>
                <c:pt idx="25">
                  <c:v>10.7</c:v>
                </c:pt>
                <c:pt idx="26">
                  <c:v>10.6</c:v>
                </c:pt>
                <c:pt idx="27">
                  <c:v>13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90E-4039-A7F4-A7DED1B19A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3548392"/>
        <c:axId val="703549832"/>
      </c:lineChart>
      <c:lineChart>
        <c:grouping val="standard"/>
        <c:varyColors val="0"/>
        <c:ser>
          <c:idx val="2"/>
          <c:order val="2"/>
          <c:tx>
            <c:strRef>
              <c:f>Sheet1!$A$4</c:f>
              <c:strCache>
                <c:ptCount val="1"/>
                <c:pt idx="0">
                  <c:v>D-dimer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x"/>
            <c:size val="8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B$1:$AC$1</c:f>
              <c:strCache>
                <c:ptCount val="28"/>
                <c:pt idx="0">
                  <c:v>POD1</c:v>
                </c:pt>
                <c:pt idx="1">
                  <c:v>POD2</c:v>
                </c:pt>
                <c:pt idx="2">
                  <c:v>POD3</c:v>
                </c:pt>
                <c:pt idx="3">
                  <c:v>POD4</c:v>
                </c:pt>
                <c:pt idx="4">
                  <c:v>POD5</c:v>
                </c:pt>
                <c:pt idx="5">
                  <c:v>POD6</c:v>
                </c:pt>
                <c:pt idx="6">
                  <c:v>POD7</c:v>
                </c:pt>
                <c:pt idx="7">
                  <c:v>POD8</c:v>
                </c:pt>
                <c:pt idx="8">
                  <c:v>POD9</c:v>
                </c:pt>
                <c:pt idx="9">
                  <c:v>POD10</c:v>
                </c:pt>
                <c:pt idx="10">
                  <c:v>POD11</c:v>
                </c:pt>
                <c:pt idx="11">
                  <c:v>POD12</c:v>
                </c:pt>
                <c:pt idx="12">
                  <c:v>POD13</c:v>
                </c:pt>
                <c:pt idx="13">
                  <c:v>POD14</c:v>
                </c:pt>
                <c:pt idx="14">
                  <c:v>POD15</c:v>
                </c:pt>
                <c:pt idx="15">
                  <c:v>POD16</c:v>
                </c:pt>
                <c:pt idx="16">
                  <c:v>POD17</c:v>
                </c:pt>
                <c:pt idx="17">
                  <c:v>POD18</c:v>
                </c:pt>
                <c:pt idx="18">
                  <c:v>POD19</c:v>
                </c:pt>
                <c:pt idx="19">
                  <c:v>POD20</c:v>
                </c:pt>
                <c:pt idx="20">
                  <c:v>POD21</c:v>
                </c:pt>
                <c:pt idx="21">
                  <c:v>POD22</c:v>
                </c:pt>
                <c:pt idx="22">
                  <c:v>POD23</c:v>
                </c:pt>
                <c:pt idx="23">
                  <c:v>POD24</c:v>
                </c:pt>
                <c:pt idx="24">
                  <c:v>POD25</c:v>
                </c:pt>
                <c:pt idx="25">
                  <c:v>POD26</c:v>
                </c:pt>
                <c:pt idx="26">
                  <c:v>POD27</c:v>
                </c:pt>
                <c:pt idx="27">
                  <c:v>POD28</c:v>
                </c:pt>
              </c:strCache>
            </c:strRef>
          </c:cat>
          <c:val>
            <c:numRef>
              <c:f>Sheet1!$B$4:$AC$4</c:f>
              <c:numCache>
                <c:formatCode>General</c:formatCode>
                <c:ptCount val="28"/>
                <c:pt idx="9">
                  <c:v>26.16</c:v>
                </c:pt>
                <c:pt idx="11">
                  <c:v>19.649999999999999</c:v>
                </c:pt>
                <c:pt idx="12">
                  <c:v>30.4</c:v>
                </c:pt>
                <c:pt idx="13">
                  <c:v>23.5</c:v>
                </c:pt>
                <c:pt idx="14">
                  <c:v>16.5</c:v>
                </c:pt>
                <c:pt idx="15">
                  <c:v>14.45</c:v>
                </c:pt>
                <c:pt idx="18">
                  <c:v>28.61</c:v>
                </c:pt>
                <c:pt idx="26">
                  <c:v>57.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E90E-4039-A7F4-A7DED1B19A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3542992"/>
        <c:axId val="703542632"/>
      </c:lineChart>
      <c:catAx>
        <c:axId val="703548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03549832"/>
        <c:crosses val="autoZero"/>
        <c:auto val="1"/>
        <c:lblAlgn val="ctr"/>
        <c:lblOffset val="100"/>
        <c:noMultiLvlLbl val="0"/>
      </c:catAx>
      <c:valAx>
        <c:axId val="703549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03548392"/>
        <c:crosses val="autoZero"/>
        <c:crossBetween val="between"/>
      </c:valAx>
      <c:valAx>
        <c:axId val="703542632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03542992"/>
        <c:crosses val="max"/>
        <c:crossBetween val="between"/>
      </c:valAx>
      <c:catAx>
        <c:axId val="70354299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70354263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0365835606385347E-2"/>
          <c:y val="0.92687389492603289"/>
          <c:w val="0.48081720900875968"/>
          <c:h val="5.290235573946644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span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708BE6-BCE2-4FC3-87D1-A72234042C02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16DDB4-41B0-40A6-840B-0AE80E5F9B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8883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8E30F9-439A-135F-5E35-24576DB035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B3D8AE1-792A-9B7E-2B54-F47B9F4516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193089-924E-8016-E37B-C65557FED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478A33-D6E6-8C3A-D58C-E07EB66BB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8C12AE3-AE9F-85E0-3B6B-7CA70C339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8526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80E0CF4-D90C-1122-C24C-CD09FC711A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CD169C6-709D-5CF1-B4EF-F95EDE32F5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1A2223-4811-9D90-E64F-06BAE41D9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6E3061D-2D28-BC43-21BA-4737E8EC8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505083-CAC5-D24A-98D8-1052FBF96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562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2A4C4FE-A2CA-A347-3064-54D4C1BCDB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9DBF738-0FAC-8881-F51A-CF651C3630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B3FF81-18D0-242C-C9EA-F8AA228D1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EC2DF6-3D1A-572D-1DAB-D147C44CD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A52AA5-F2DD-9E59-277F-FACBC8F70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725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7CEB7E-BD48-3EEB-8AFF-EAD8E7B103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39C8A8A-7578-B11E-6642-B977E84DC3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C6620D-8633-3E4E-1304-15E861FB9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F94C7A-9EB7-0A90-AEBD-31478BB9F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D74A1FC-82FE-6526-C0B9-9F8D8697E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948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0F87CE-D815-3064-AA7F-3C6D89B139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3B69C47-9DA5-065A-4EA9-E3EAF5EFA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471363-E842-A0CE-9AE0-1DC24B3B73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C88595-CF3A-924C-4CB2-4A39B7B39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75377F-7465-24DF-1CA0-69CC24AFF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353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A751C3-ECA1-A6D7-CE50-D0ACFD0A55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A8DB7CF-6301-9AFC-76EC-E17171DA94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0233C6A-4183-2D10-506B-AAB6693500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38B7B25-49BC-D1EC-E608-375B3C748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55E5E9-BAFD-AA5D-FBA3-2C123F7D0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6F1C1E6-2BE1-FAE2-DE19-34DA8B1D0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1124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CCB30E-78AA-F0CD-FC80-7E166FD969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52A2D86-576C-917C-20A1-9A21E1CDBE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2395315-062A-32B1-B82C-E1AE1150C1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2508B55-8B3B-74C2-D44B-02656E1E9D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338322F-03F4-3986-39D7-1905A47151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0C3A7A8-65C4-C01B-077F-C86D82006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EA68DCD-49C1-685C-9FAB-A1D8A768E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B0CDBEA-0B5A-105A-EF32-9CE9C039F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495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98092C-A603-C631-7A0A-618E320E91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2C66F72-5127-1896-3A4B-7695ABE22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4D2E9FD-0193-FC19-438C-3449D2791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63068D6-167D-2681-C7B8-B08BE0E13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7711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4CE74CA-DF75-C4EE-0ECE-342D1959A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03FCD6E-47F3-AF39-CF92-FFEFDA46D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6CA46CD-CC57-58D8-B8C7-F616903A26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8697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06E763-FB7B-E9F6-3F60-7F8B363416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1E61100-EAA6-1B6D-7F70-F619E4E318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136ECEB-4AC1-4B32-676E-0E6C6C7ECA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E6177A2-18B4-4C86-8D09-C4D2374B3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1291146-C194-CD09-4615-520961257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00B28B3-A400-E71C-48F9-493E7214C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5951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5728E6-D540-676C-C185-AA514EA055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4380A3A-671C-6D43-B404-342894C524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CFCC96A-B373-CF53-65DD-6829EA0407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DE65C0-EF0B-2B65-6893-163114920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0E7E00-B401-B0BE-2BD6-99C32C87A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5FFF5D-6375-BC7E-5250-C39D1E37C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7958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800FAF5-9276-DB91-C5E8-C6BBFA1999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D8868EF-94FE-1615-E024-C53A8F9CC2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CE1F1E-64CB-B6B2-8F69-AFB6558B02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D0F55-2193-4023-B124-EC89EFAF66AC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BB4C67-88D4-B79E-2E26-15202DEE80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22E484-7B27-25C4-6569-7B2049706A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7A3F7-41B0-426A-B8B1-C607414417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477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CB7DC29-0954-D032-446A-20F9179E10BE}"/>
              </a:ext>
            </a:extLst>
          </p:cNvPr>
          <p:cNvSpPr txBox="1"/>
          <p:nvPr/>
        </p:nvSpPr>
        <p:spPr>
          <a:xfrm>
            <a:off x="268942" y="80938"/>
            <a:ext cx="273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Information 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A6BF3971-3132-B659-5959-24FD58C4A01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6" t="25174" r="6077" b="13839"/>
          <a:stretch/>
        </p:blipFill>
        <p:spPr>
          <a:xfrm>
            <a:off x="3092825" y="567791"/>
            <a:ext cx="3339629" cy="2284441"/>
          </a:xfrm>
          <a:prstGeom prst="rect">
            <a:avLst/>
          </a:prstGeom>
        </p:spPr>
      </p:pic>
      <p:sp>
        <p:nvSpPr>
          <p:cNvPr id="31" name="二等辺三角形 30">
            <a:extLst>
              <a:ext uri="{FF2B5EF4-FFF2-40B4-BE49-F238E27FC236}">
                <a16:creationId xmlns:a16="http://schemas.microsoft.com/office/drawing/2014/main" id="{8FA056CF-FE68-F932-B5FA-93C6A089BAFB}"/>
              </a:ext>
            </a:extLst>
          </p:cNvPr>
          <p:cNvSpPr/>
          <p:nvPr/>
        </p:nvSpPr>
        <p:spPr>
          <a:xfrm rot="10800000">
            <a:off x="4067763" y="744533"/>
            <a:ext cx="108000" cy="180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二等辺三角形 31">
            <a:extLst>
              <a:ext uri="{FF2B5EF4-FFF2-40B4-BE49-F238E27FC236}">
                <a16:creationId xmlns:a16="http://schemas.microsoft.com/office/drawing/2014/main" id="{658ACC17-BFD0-F817-07F5-20CA39557712}"/>
              </a:ext>
            </a:extLst>
          </p:cNvPr>
          <p:cNvSpPr/>
          <p:nvPr/>
        </p:nvSpPr>
        <p:spPr>
          <a:xfrm rot="10800000">
            <a:off x="4559060" y="677819"/>
            <a:ext cx="108000" cy="180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二等辺三角形 32">
            <a:extLst>
              <a:ext uri="{FF2B5EF4-FFF2-40B4-BE49-F238E27FC236}">
                <a16:creationId xmlns:a16="http://schemas.microsoft.com/office/drawing/2014/main" id="{3CD67A2E-F701-07CD-AF47-FC3EE783F7C5}"/>
              </a:ext>
            </a:extLst>
          </p:cNvPr>
          <p:cNvSpPr/>
          <p:nvPr/>
        </p:nvSpPr>
        <p:spPr>
          <a:xfrm rot="10800000">
            <a:off x="4854187" y="694279"/>
            <a:ext cx="108000" cy="180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二等辺三角形 33">
            <a:extLst>
              <a:ext uri="{FF2B5EF4-FFF2-40B4-BE49-F238E27FC236}">
                <a16:creationId xmlns:a16="http://schemas.microsoft.com/office/drawing/2014/main" id="{6B4181C9-03F9-7FEF-DFA4-F7A0F40BF418}"/>
              </a:ext>
            </a:extLst>
          </p:cNvPr>
          <p:cNvSpPr/>
          <p:nvPr/>
        </p:nvSpPr>
        <p:spPr>
          <a:xfrm rot="10800000">
            <a:off x="5577691" y="792192"/>
            <a:ext cx="108000" cy="180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5" name="図 34">
            <a:extLst>
              <a:ext uri="{FF2B5EF4-FFF2-40B4-BE49-F238E27FC236}">
                <a16:creationId xmlns:a16="http://schemas.microsoft.com/office/drawing/2014/main" id="{93A3E369-7CD6-9E37-F9F3-95B613D8776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62" t="2087" b="3028"/>
          <a:stretch/>
        </p:blipFill>
        <p:spPr>
          <a:xfrm>
            <a:off x="401459" y="3011095"/>
            <a:ext cx="2558601" cy="2024524"/>
          </a:xfrm>
          <a:prstGeom prst="rect">
            <a:avLst/>
          </a:prstGeom>
        </p:spPr>
      </p:pic>
      <p:sp>
        <p:nvSpPr>
          <p:cNvPr id="36" name="二等辺三角形 35">
            <a:extLst>
              <a:ext uri="{FF2B5EF4-FFF2-40B4-BE49-F238E27FC236}">
                <a16:creationId xmlns:a16="http://schemas.microsoft.com/office/drawing/2014/main" id="{54FEA5F4-9581-6FDD-61AC-C92572E7C853}"/>
              </a:ext>
            </a:extLst>
          </p:cNvPr>
          <p:cNvSpPr/>
          <p:nvPr/>
        </p:nvSpPr>
        <p:spPr>
          <a:xfrm rot="16489973">
            <a:off x="2000026" y="3746269"/>
            <a:ext cx="108000" cy="180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38B326C-955D-D373-6F60-48A93AB1F395}"/>
              </a:ext>
            </a:extLst>
          </p:cNvPr>
          <p:cNvSpPr txBox="1"/>
          <p:nvPr/>
        </p:nvSpPr>
        <p:spPr>
          <a:xfrm>
            <a:off x="3120885" y="53153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03F4B68-2699-0E68-A249-6CB18EE72315}"/>
              </a:ext>
            </a:extLst>
          </p:cNvPr>
          <p:cNvSpPr txBox="1"/>
          <p:nvPr/>
        </p:nvSpPr>
        <p:spPr>
          <a:xfrm>
            <a:off x="427621" y="2969755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067EFE51-067F-F053-517A-EC38145AA464}"/>
              </a:ext>
            </a:extLst>
          </p:cNvPr>
          <p:cNvGrpSpPr>
            <a:grpSpLocks noChangeAspect="1"/>
          </p:cNvGrpSpPr>
          <p:nvPr/>
        </p:nvGrpSpPr>
        <p:grpSpPr>
          <a:xfrm>
            <a:off x="381181" y="567792"/>
            <a:ext cx="2578880" cy="2284441"/>
            <a:chOff x="340661" y="567769"/>
            <a:chExt cx="2763520" cy="2448000"/>
          </a:xfrm>
        </p:grpSpPr>
        <p:pic>
          <p:nvPicPr>
            <p:cNvPr id="40" name="図 39">
              <a:extLst>
                <a:ext uri="{FF2B5EF4-FFF2-40B4-BE49-F238E27FC236}">
                  <a16:creationId xmlns:a16="http://schemas.microsoft.com/office/drawing/2014/main" id="{2E82CE50-F7FB-0108-52BC-E43BE241FB3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47" r="2643"/>
            <a:stretch/>
          </p:blipFill>
          <p:spPr>
            <a:xfrm>
              <a:off x="340661" y="567769"/>
              <a:ext cx="2763520" cy="2448000"/>
            </a:xfrm>
            <a:prstGeom prst="rect">
              <a:avLst/>
            </a:prstGeom>
          </p:spPr>
        </p:pic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874AC27F-8F6B-B9A0-7123-F468E2FFAE0E}"/>
                </a:ext>
              </a:extLst>
            </p:cNvPr>
            <p:cNvSpPr/>
            <p:nvPr/>
          </p:nvSpPr>
          <p:spPr>
            <a:xfrm>
              <a:off x="340661" y="2915039"/>
              <a:ext cx="216000" cy="10073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5B86BD4-91FB-BA4F-0708-C99729BEE264}"/>
              </a:ext>
            </a:extLst>
          </p:cNvPr>
          <p:cNvSpPr txBox="1"/>
          <p:nvPr/>
        </p:nvSpPr>
        <p:spPr>
          <a:xfrm>
            <a:off x="413367" y="54986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二等辺三角形 46">
            <a:extLst>
              <a:ext uri="{FF2B5EF4-FFF2-40B4-BE49-F238E27FC236}">
                <a16:creationId xmlns:a16="http://schemas.microsoft.com/office/drawing/2014/main" id="{50F60E74-60F6-0A5B-F9C7-9D82CF2D2F7E}"/>
              </a:ext>
            </a:extLst>
          </p:cNvPr>
          <p:cNvSpPr/>
          <p:nvPr/>
        </p:nvSpPr>
        <p:spPr>
          <a:xfrm rot="16489973">
            <a:off x="1616620" y="1992795"/>
            <a:ext cx="108000" cy="180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6965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AC641654-FDA5-4AF8-02B7-325B8B4216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3592667"/>
              </p:ext>
            </p:extLst>
          </p:nvPr>
        </p:nvGraphicFramePr>
        <p:xfrm>
          <a:off x="1031132" y="1006526"/>
          <a:ext cx="10369685" cy="56517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CB6B17C3-3209-AB90-9E63-803273DAA226}"/>
              </a:ext>
            </a:extLst>
          </p:cNvPr>
          <p:cNvGrpSpPr/>
          <p:nvPr/>
        </p:nvGrpSpPr>
        <p:grpSpPr>
          <a:xfrm>
            <a:off x="1698846" y="6474864"/>
            <a:ext cx="4650440" cy="277002"/>
            <a:chOff x="2032506" y="6165023"/>
            <a:chExt cx="4650440" cy="277002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B9D6A54-6629-132D-9A09-8486886960BD}"/>
                </a:ext>
              </a:extLst>
            </p:cNvPr>
            <p:cNvSpPr txBox="1"/>
            <p:nvPr/>
          </p:nvSpPr>
          <p:spPr>
            <a:xfrm>
              <a:off x="2032506" y="6165025"/>
              <a:ext cx="5277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unit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9E5FE397-C69C-1338-111C-CDB1E0DC3860}"/>
                </a:ext>
              </a:extLst>
            </p:cNvPr>
            <p:cNvSpPr txBox="1"/>
            <p:nvPr/>
          </p:nvSpPr>
          <p:spPr>
            <a:xfrm>
              <a:off x="2876146" y="6165025"/>
              <a:ext cx="5277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unit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D4F9A6FB-E122-7142-A8D0-5D598646CC01}"/>
                </a:ext>
              </a:extLst>
            </p:cNvPr>
            <p:cNvSpPr txBox="1"/>
            <p:nvPr/>
          </p:nvSpPr>
          <p:spPr>
            <a:xfrm>
              <a:off x="3612206" y="6165026"/>
              <a:ext cx="5277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unit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11A0863-2E9B-6890-6C78-6AFFEA149199}"/>
                </a:ext>
              </a:extLst>
            </p:cNvPr>
            <p:cNvSpPr txBox="1"/>
            <p:nvPr/>
          </p:nvSpPr>
          <p:spPr>
            <a:xfrm>
              <a:off x="4267744" y="6165025"/>
              <a:ext cx="5790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g/dL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042B3B2D-4085-D1C4-08F7-332EA70042D5}"/>
                </a:ext>
              </a:extLst>
            </p:cNvPr>
            <p:cNvSpPr txBox="1"/>
            <p:nvPr/>
          </p:nvSpPr>
          <p:spPr>
            <a:xfrm>
              <a:off x="4956119" y="6165023"/>
              <a:ext cx="79376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明朝" panose="02020609040205080304" pitchFamily="17" charset="-128"/>
                </a:rPr>
                <a:t>(x10</a:t>
              </a:r>
              <a:r>
                <a:rPr lang="en-US" altLang="ja-JP" sz="1200" kern="1200" baseline="30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明朝" panose="02020609040205080304" pitchFamily="17" charset="-128"/>
                </a:rPr>
                <a:t>4</a:t>
              </a:r>
              <a:r>
                <a:rPr lang="en-US" altLang="ja-JP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明朝" panose="02020609040205080304" pitchFamily="17" charset="-128"/>
                </a:rPr>
                <a:t>/</a:t>
              </a:r>
              <a:r>
                <a:rPr lang="en-US" altLang="ja-JP" sz="1200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明朝" panose="02020609040205080304" pitchFamily="17" charset="-128"/>
                </a:rPr>
                <a:t>μL</a:t>
              </a:r>
              <a:r>
                <a:rPr lang="en-US" altLang="ja-JP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明朝" panose="02020609040205080304" pitchFamily="17" charset="-128"/>
                </a:rPr>
                <a:t>)</a:t>
              </a:r>
              <a:endParaRPr lang="ja-JP" altLang="en-US" sz="1200" dirty="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C24CF5E2-3E1C-6E46-DA00-7DE0B4460202}"/>
                </a:ext>
              </a:extLst>
            </p:cNvPr>
            <p:cNvSpPr txBox="1"/>
            <p:nvPr/>
          </p:nvSpPr>
          <p:spPr>
            <a:xfrm>
              <a:off x="5889186" y="6165024"/>
              <a:ext cx="79376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明朝" panose="02020609040205080304" pitchFamily="17" charset="-128"/>
                </a:rPr>
                <a:t>(</a:t>
              </a:r>
              <a:r>
                <a:rPr lang="en-US" altLang="ja-JP" sz="1200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明朝" panose="02020609040205080304" pitchFamily="17" charset="-128"/>
                </a:rPr>
                <a:t>μg</a:t>
              </a:r>
              <a:r>
                <a:rPr lang="en-US" altLang="ja-JP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明朝" panose="02020609040205080304" pitchFamily="17" charset="-128"/>
                </a:rPr>
                <a:t>/mL)</a:t>
              </a:r>
              <a:endParaRPr lang="ja-JP" altLang="en-US" sz="1200" dirty="0"/>
            </a:p>
          </p:txBody>
        </p:sp>
      </p:grp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4AB2E0C-E755-FA3F-DC02-77C5CA1E2DE0}"/>
              </a:ext>
            </a:extLst>
          </p:cNvPr>
          <p:cNvSpPr txBox="1"/>
          <p:nvPr/>
        </p:nvSpPr>
        <p:spPr>
          <a:xfrm>
            <a:off x="575739" y="2280847"/>
            <a:ext cx="430887" cy="238327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C / FFP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 / Hb / PLT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69F7C62-A0FC-9F9D-BE64-BE5AA438545B}"/>
              </a:ext>
            </a:extLst>
          </p:cNvPr>
          <p:cNvSpPr txBox="1"/>
          <p:nvPr/>
        </p:nvSpPr>
        <p:spPr>
          <a:xfrm>
            <a:off x="11400817" y="3044470"/>
            <a:ext cx="430887" cy="82685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dimer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二等辺三角形 23">
            <a:extLst>
              <a:ext uri="{FF2B5EF4-FFF2-40B4-BE49-F238E27FC236}">
                <a16:creationId xmlns:a16="http://schemas.microsoft.com/office/drawing/2014/main" id="{C4EDDFDE-1353-2E3F-FA82-748379FBA467}"/>
              </a:ext>
            </a:extLst>
          </p:cNvPr>
          <p:cNvSpPr/>
          <p:nvPr/>
        </p:nvSpPr>
        <p:spPr>
          <a:xfrm>
            <a:off x="6696495" y="6351196"/>
            <a:ext cx="108000" cy="216000"/>
          </a:xfrm>
          <a:prstGeom prst="triangl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E6D0E91-13D1-3B80-C40C-6115963DCACC}"/>
              </a:ext>
            </a:extLst>
          </p:cNvPr>
          <p:cNvSpPr txBox="1"/>
          <p:nvPr/>
        </p:nvSpPr>
        <p:spPr>
          <a:xfrm>
            <a:off x="8101600" y="6228643"/>
            <a:ext cx="10383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 with </a:t>
            </a:r>
          </a:p>
          <a:p>
            <a:pPr algn="ct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famostat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7E1A1E9-05A9-E8FE-D22D-EF76EF0704CE}"/>
              </a:ext>
            </a:extLst>
          </p:cNvPr>
          <p:cNvSpPr txBox="1"/>
          <p:nvPr/>
        </p:nvSpPr>
        <p:spPr>
          <a:xfrm>
            <a:off x="6750495" y="6228643"/>
            <a:ext cx="103834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 with </a:t>
            </a:r>
          </a:p>
          <a:p>
            <a:pPr algn="ct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lteparin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二等辺三角形 29">
            <a:extLst>
              <a:ext uri="{FF2B5EF4-FFF2-40B4-BE49-F238E27FC236}">
                <a16:creationId xmlns:a16="http://schemas.microsoft.com/office/drawing/2014/main" id="{05C5CFA6-C482-439B-2F73-B5D6ED1FA397}"/>
              </a:ext>
            </a:extLst>
          </p:cNvPr>
          <p:cNvSpPr/>
          <p:nvPr/>
        </p:nvSpPr>
        <p:spPr>
          <a:xfrm>
            <a:off x="7999498" y="6351196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二等辺三角形 30">
            <a:extLst>
              <a:ext uri="{FF2B5EF4-FFF2-40B4-BE49-F238E27FC236}">
                <a16:creationId xmlns:a16="http://schemas.microsoft.com/office/drawing/2014/main" id="{654C99A9-52A9-354C-62F1-6C41072A592D}"/>
              </a:ext>
            </a:extLst>
          </p:cNvPr>
          <p:cNvSpPr/>
          <p:nvPr/>
        </p:nvSpPr>
        <p:spPr>
          <a:xfrm>
            <a:off x="1806426" y="5853357"/>
            <a:ext cx="108000" cy="216000"/>
          </a:xfrm>
          <a:prstGeom prst="triangl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二等辺三角形 31">
            <a:extLst>
              <a:ext uri="{FF2B5EF4-FFF2-40B4-BE49-F238E27FC236}">
                <a16:creationId xmlns:a16="http://schemas.microsoft.com/office/drawing/2014/main" id="{CE1C7838-0BA8-0A10-5D90-40FCDB0C3213}"/>
              </a:ext>
            </a:extLst>
          </p:cNvPr>
          <p:cNvSpPr/>
          <p:nvPr/>
        </p:nvSpPr>
        <p:spPr>
          <a:xfrm>
            <a:off x="2488486" y="5853357"/>
            <a:ext cx="108000" cy="216000"/>
          </a:xfrm>
          <a:prstGeom prst="triangl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二等辺三角形 32">
            <a:extLst>
              <a:ext uri="{FF2B5EF4-FFF2-40B4-BE49-F238E27FC236}">
                <a16:creationId xmlns:a16="http://schemas.microsoft.com/office/drawing/2014/main" id="{020C76F0-EE16-4F42-6E6B-B40072322BDE}"/>
              </a:ext>
            </a:extLst>
          </p:cNvPr>
          <p:cNvSpPr/>
          <p:nvPr/>
        </p:nvSpPr>
        <p:spPr>
          <a:xfrm>
            <a:off x="3170546" y="5853357"/>
            <a:ext cx="108000" cy="216000"/>
          </a:xfrm>
          <a:prstGeom prst="triangl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二等辺三角形 34">
            <a:extLst>
              <a:ext uri="{FF2B5EF4-FFF2-40B4-BE49-F238E27FC236}">
                <a16:creationId xmlns:a16="http://schemas.microsoft.com/office/drawing/2014/main" id="{1AA289F8-CFE4-6BA5-A3C6-AB1B54228B95}"/>
              </a:ext>
            </a:extLst>
          </p:cNvPr>
          <p:cNvSpPr/>
          <p:nvPr/>
        </p:nvSpPr>
        <p:spPr>
          <a:xfrm>
            <a:off x="3888020" y="5853357"/>
            <a:ext cx="108000" cy="216000"/>
          </a:xfrm>
          <a:prstGeom prst="triangl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二等辺三角形 36">
            <a:extLst>
              <a:ext uri="{FF2B5EF4-FFF2-40B4-BE49-F238E27FC236}">
                <a16:creationId xmlns:a16="http://schemas.microsoft.com/office/drawing/2014/main" id="{6D809593-B350-B8C7-772C-8050AE61AA40}"/>
              </a:ext>
            </a:extLst>
          </p:cNvPr>
          <p:cNvSpPr/>
          <p:nvPr/>
        </p:nvSpPr>
        <p:spPr>
          <a:xfrm>
            <a:off x="4940389" y="5854749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二等辺三角形 38">
            <a:extLst>
              <a:ext uri="{FF2B5EF4-FFF2-40B4-BE49-F238E27FC236}">
                <a16:creationId xmlns:a16="http://schemas.microsoft.com/office/drawing/2014/main" id="{5571D40F-F58B-F85B-8268-C843040EFC03}"/>
              </a:ext>
            </a:extLst>
          </p:cNvPr>
          <p:cNvSpPr/>
          <p:nvPr/>
        </p:nvSpPr>
        <p:spPr>
          <a:xfrm>
            <a:off x="5889694" y="5864477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二等辺三角形 39">
            <a:extLst>
              <a:ext uri="{FF2B5EF4-FFF2-40B4-BE49-F238E27FC236}">
                <a16:creationId xmlns:a16="http://schemas.microsoft.com/office/drawing/2014/main" id="{5119CC32-D0E2-C8BD-FDCC-45E0C36FC494}"/>
              </a:ext>
            </a:extLst>
          </p:cNvPr>
          <p:cNvSpPr/>
          <p:nvPr/>
        </p:nvSpPr>
        <p:spPr>
          <a:xfrm>
            <a:off x="6518207" y="5864477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二等辺三角形 40">
            <a:extLst>
              <a:ext uri="{FF2B5EF4-FFF2-40B4-BE49-F238E27FC236}">
                <a16:creationId xmlns:a16="http://schemas.microsoft.com/office/drawing/2014/main" id="{F4B3F7C5-8214-CD11-45A5-3416085E7D32}"/>
              </a:ext>
            </a:extLst>
          </p:cNvPr>
          <p:cNvSpPr/>
          <p:nvPr/>
        </p:nvSpPr>
        <p:spPr>
          <a:xfrm>
            <a:off x="7199814" y="5864477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二等辺三角形 41">
            <a:extLst>
              <a:ext uri="{FF2B5EF4-FFF2-40B4-BE49-F238E27FC236}">
                <a16:creationId xmlns:a16="http://schemas.microsoft.com/office/drawing/2014/main" id="{344ECF01-C5C1-8793-FE21-6C379118471B}"/>
              </a:ext>
            </a:extLst>
          </p:cNvPr>
          <p:cNvSpPr/>
          <p:nvPr/>
        </p:nvSpPr>
        <p:spPr>
          <a:xfrm>
            <a:off x="7917288" y="5864477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二等辺三角形 42">
            <a:extLst>
              <a:ext uri="{FF2B5EF4-FFF2-40B4-BE49-F238E27FC236}">
                <a16:creationId xmlns:a16="http://schemas.microsoft.com/office/drawing/2014/main" id="{2AC3FAE6-7AE6-FD25-BA9B-48A9DD61EA74}"/>
              </a:ext>
            </a:extLst>
          </p:cNvPr>
          <p:cNvSpPr/>
          <p:nvPr/>
        </p:nvSpPr>
        <p:spPr>
          <a:xfrm>
            <a:off x="8233597" y="5864477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二等辺三角形 43">
            <a:extLst>
              <a:ext uri="{FF2B5EF4-FFF2-40B4-BE49-F238E27FC236}">
                <a16:creationId xmlns:a16="http://schemas.microsoft.com/office/drawing/2014/main" id="{71EE109B-60C6-FF15-ABA4-AF2A0316525B}"/>
              </a:ext>
            </a:extLst>
          </p:cNvPr>
          <p:cNvSpPr/>
          <p:nvPr/>
        </p:nvSpPr>
        <p:spPr>
          <a:xfrm>
            <a:off x="8554842" y="5864477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二等辺三角形 44">
            <a:extLst>
              <a:ext uri="{FF2B5EF4-FFF2-40B4-BE49-F238E27FC236}">
                <a16:creationId xmlns:a16="http://schemas.microsoft.com/office/drawing/2014/main" id="{D578C11E-7B2F-CCC6-124F-7F9AF6223C0D}"/>
              </a:ext>
            </a:extLst>
          </p:cNvPr>
          <p:cNvSpPr/>
          <p:nvPr/>
        </p:nvSpPr>
        <p:spPr>
          <a:xfrm>
            <a:off x="9236902" y="5864477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二等辺三角形 45">
            <a:extLst>
              <a:ext uri="{FF2B5EF4-FFF2-40B4-BE49-F238E27FC236}">
                <a16:creationId xmlns:a16="http://schemas.microsoft.com/office/drawing/2014/main" id="{EE84EBA7-BD29-4191-4A94-5C878C0A2EF9}"/>
              </a:ext>
            </a:extLst>
          </p:cNvPr>
          <p:cNvSpPr/>
          <p:nvPr/>
        </p:nvSpPr>
        <p:spPr>
          <a:xfrm>
            <a:off x="9595514" y="5864477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二等辺三角形 46">
            <a:extLst>
              <a:ext uri="{FF2B5EF4-FFF2-40B4-BE49-F238E27FC236}">
                <a16:creationId xmlns:a16="http://schemas.microsoft.com/office/drawing/2014/main" id="{272DC07F-2C6C-2835-9DCD-319890F14452}"/>
              </a:ext>
            </a:extLst>
          </p:cNvPr>
          <p:cNvSpPr/>
          <p:nvPr/>
        </p:nvSpPr>
        <p:spPr>
          <a:xfrm>
            <a:off x="10277574" y="5864477"/>
            <a:ext cx="108000" cy="216000"/>
          </a:xfrm>
          <a:prstGeom prst="triangl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二等辺三角形 1">
            <a:extLst>
              <a:ext uri="{FF2B5EF4-FFF2-40B4-BE49-F238E27FC236}">
                <a16:creationId xmlns:a16="http://schemas.microsoft.com/office/drawing/2014/main" id="{2BAB7FA6-9C03-2D33-D82C-9ACCBDD51E54}"/>
              </a:ext>
            </a:extLst>
          </p:cNvPr>
          <p:cNvSpPr/>
          <p:nvPr/>
        </p:nvSpPr>
        <p:spPr>
          <a:xfrm flipV="1">
            <a:off x="9344704" y="6366864"/>
            <a:ext cx="108000" cy="216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3254A70-1925-8420-8042-742465A47D9C}"/>
              </a:ext>
            </a:extLst>
          </p:cNvPr>
          <p:cNvSpPr txBox="1"/>
          <p:nvPr/>
        </p:nvSpPr>
        <p:spPr>
          <a:xfrm>
            <a:off x="9443529" y="6228643"/>
            <a:ext cx="10383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doscopic </a:t>
            </a:r>
          </a:p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mostasi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二等辺三角形 3">
            <a:extLst>
              <a:ext uri="{FF2B5EF4-FFF2-40B4-BE49-F238E27FC236}">
                <a16:creationId xmlns:a16="http://schemas.microsoft.com/office/drawing/2014/main" id="{34042717-041F-99A7-9B90-76EC9D2B0031}"/>
              </a:ext>
            </a:extLst>
          </p:cNvPr>
          <p:cNvSpPr/>
          <p:nvPr/>
        </p:nvSpPr>
        <p:spPr>
          <a:xfrm flipV="1">
            <a:off x="4607570" y="1176299"/>
            <a:ext cx="108000" cy="216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二等辺三角形 9">
            <a:extLst>
              <a:ext uri="{FF2B5EF4-FFF2-40B4-BE49-F238E27FC236}">
                <a16:creationId xmlns:a16="http://schemas.microsoft.com/office/drawing/2014/main" id="{C7DE37A8-8554-77E7-57C8-47EEA713B18A}"/>
              </a:ext>
            </a:extLst>
          </p:cNvPr>
          <p:cNvSpPr/>
          <p:nvPr/>
        </p:nvSpPr>
        <p:spPr>
          <a:xfrm flipV="1">
            <a:off x="1473690" y="1176299"/>
            <a:ext cx="108000" cy="216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二等辺三角形 16">
            <a:extLst>
              <a:ext uri="{FF2B5EF4-FFF2-40B4-BE49-F238E27FC236}">
                <a16:creationId xmlns:a16="http://schemas.microsoft.com/office/drawing/2014/main" id="{B3DC12B6-3A6D-5443-C0D9-B1F46906CCD1}"/>
              </a:ext>
            </a:extLst>
          </p:cNvPr>
          <p:cNvSpPr/>
          <p:nvPr/>
        </p:nvSpPr>
        <p:spPr>
          <a:xfrm flipV="1">
            <a:off x="4956560" y="1176299"/>
            <a:ext cx="108000" cy="216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二等辺三角形 17">
            <a:extLst>
              <a:ext uri="{FF2B5EF4-FFF2-40B4-BE49-F238E27FC236}">
                <a16:creationId xmlns:a16="http://schemas.microsoft.com/office/drawing/2014/main" id="{81669F2C-0239-0ED3-32EE-9CFB8328E2DA}"/>
              </a:ext>
            </a:extLst>
          </p:cNvPr>
          <p:cNvSpPr/>
          <p:nvPr/>
        </p:nvSpPr>
        <p:spPr>
          <a:xfrm flipV="1">
            <a:off x="5315147" y="1178777"/>
            <a:ext cx="108000" cy="216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513A358A-46D2-351C-8E1E-612F9A926E92}"/>
              </a:ext>
            </a:extLst>
          </p:cNvPr>
          <p:cNvCxnSpPr>
            <a:cxnSpLocks/>
          </p:cNvCxnSpPr>
          <p:nvPr/>
        </p:nvCxnSpPr>
        <p:spPr>
          <a:xfrm>
            <a:off x="5108886" y="971395"/>
            <a:ext cx="0" cy="36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313DC91-ED4D-DD72-DFFC-10C8147101B6}"/>
              </a:ext>
            </a:extLst>
          </p:cNvPr>
          <p:cNvSpPr txBox="1"/>
          <p:nvPr/>
        </p:nvSpPr>
        <p:spPr>
          <a:xfrm>
            <a:off x="4661570" y="393222"/>
            <a:ext cx="96212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ergent</a:t>
            </a:r>
          </a:p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gery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DA4FE0D-11DA-5AA0-4460-10B6E66348E4}"/>
              </a:ext>
            </a:extLst>
          </p:cNvPr>
          <p:cNvSpPr txBox="1"/>
          <p:nvPr/>
        </p:nvSpPr>
        <p:spPr>
          <a:xfrm>
            <a:off x="6966716" y="516332"/>
            <a:ext cx="5741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eu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4B631240-A531-AF04-C7C6-83796A623C55}"/>
              </a:ext>
            </a:extLst>
          </p:cNvPr>
          <p:cNvCxnSpPr>
            <a:cxnSpLocks/>
          </p:cNvCxnSpPr>
          <p:nvPr/>
        </p:nvCxnSpPr>
        <p:spPr>
          <a:xfrm>
            <a:off x="7253814" y="971394"/>
            <a:ext cx="0" cy="36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A416AD3-BE0A-E8EA-E9AF-FDDA187A3DDE}"/>
              </a:ext>
            </a:extLst>
          </p:cNvPr>
          <p:cNvSpPr txBox="1"/>
          <p:nvPr/>
        </p:nvSpPr>
        <p:spPr>
          <a:xfrm>
            <a:off x="268942" y="80938"/>
            <a:ext cx="273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Information 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4895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5</TotalTime>
  <Words>54</Words>
  <Application>Microsoft Office PowerPoint</Application>
  <PresentationFormat>ワイド画面</PresentationFormat>
  <Paragraphs>2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博之 遠藤</dc:creator>
  <cp:lastModifiedBy>博之 遠藤</cp:lastModifiedBy>
  <cp:revision>36</cp:revision>
  <dcterms:created xsi:type="dcterms:W3CDTF">2024-11-05T11:20:45Z</dcterms:created>
  <dcterms:modified xsi:type="dcterms:W3CDTF">2025-12-07T09:15:23Z</dcterms:modified>
</cp:coreProperties>
</file>